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5126"/>
  </p:normalViewPr>
  <p:slideViewPr>
    <p:cSldViewPr snapToGrid="0">
      <p:cViewPr varScale="1">
        <p:scale>
          <a:sx n="95" d="100"/>
          <a:sy n="95" d="100"/>
        </p:scale>
        <p:origin x="68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792C929-D8A1-5486-91B1-0A741DEBF75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8D2B003-08F7-0AFF-7091-CA6D0078523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8F87FAC-B9B2-6402-5E70-CCE667CF33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9E1C34-B17B-674D-AD67-47CF507AABC5}" type="datetimeFigureOut">
              <a:rPr lang="en-US" smtClean="0"/>
              <a:t>1/26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FB68619-D6BD-9AC1-E60C-E1F6BC74B1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B971642-888D-9721-5228-2087D5683F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88CAA4-0770-4949-AFC1-F1EECC2C14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06065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225615-5EC1-2B3D-A3CE-D2BA84641A8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B7E168B-AE3C-453A-4721-630F05C106D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268BD06-D3AB-F1A7-FE64-4C7341E6AD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9E1C34-B17B-674D-AD67-47CF507AABC5}" type="datetimeFigureOut">
              <a:rPr lang="en-US" smtClean="0"/>
              <a:t>1/26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5AF951C-6C74-FD76-7DF0-E481F93ED6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903A7A1-D5B7-08E9-9164-4036656C53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88CAA4-0770-4949-AFC1-F1EECC2C14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31134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1D41389-2AB6-2F1A-F8AC-2905E2B77D0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8750A5F-FC66-0146-DD29-0CED239700F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C2533C5-5682-8F83-04DC-4A210AE70E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9E1C34-B17B-674D-AD67-47CF507AABC5}" type="datetimeFigureOut">
              <a:rPr lang="en-US" smtClean="0"/>
              <a:t>1/26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16943F0-046C-0DC2-C2AF-9E856FF27C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ECCD59D-9057-96F0-3ABC-227C81A79C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88CAA4-0770-4949-AFC1-F1EECC2C14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01416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EB5D361-125E-23BE-0D94-2BC2463217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4CA1F4A-DEA0-5288-970D-9EE67140C42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F66829F-5CA1-AFAA-09F6-075BB41816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9E1C34-B17B-674D-AD67-47CF507AABC5}" type="datetimeFigureOut">
              <a:rPr lang="en-US" smtClean="0"/>
              <a:t>1/26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AA1320E-2FA3-99B3-05DE-842BFD13B2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A0C9ECC-B509-4CCF-F9DA-145FA6D6AA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88CAA4-0770-4949-AFC1-F1EECC2C14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47441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A9C1DC-94C1-917C-0DCC-D808DAC41CA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49FA970-D156-AB84-0A0F-4A2BD1C18B2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7BEB279-A725-A754-71E6-51D9F67E18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9E1C34-B17B-674D-AD67-47CF507AABC5}" type="datetimeFigureOut">
              <a:rPr lang="en-US" smtClean="0"/>
              <a:t>1/26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A2240BF-36E9-B9B2-3F03-51AF4083EE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AA6CEAF-A411-FE26-DCAA-1A59CF5013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88CAA4-0770-4949-AFC1-F1EECC2C14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07598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81CB96-1A8B-6F0A-8534-8A342D90C00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CAAC3CB-2FD8-DC99-AD2E-BF3BB8294CC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1487F13-C580-535B-01BE-BB190BA9EA6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C02017E-04F0-F660-A1AC-C9C685F8DC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9E1C34-B17B-674D-AD67-47CF507AABC5}" type="datetimeFigureOut">
              <a:rPr lang="en-US" smtClean="0"/>
              <a:t>1/26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0C75000-2E3E-AED3-AF02-FE0E111B10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B3F64EE-324F-7C7B-E80F-7FB70BF515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88CAA4-0770-4949-AFC1-F1EECC2C14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48333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662512-0BBE-CD9D-C317-292015CB92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28746DA-FF7C-C65F-A603-2A57D0405E1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74C7118-3E72-40A7-D4D9-A98539D22A0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1CA7E0E-5006-70EE-82F1-26DC3330125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46517B0-C7B2-260A-EE99-3C2921C7C5D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879DFA4-A38E-8D4A-AB79-570FB6FB01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9E1C34-B17B-674D-AD67-47CF507AABC5}" type="datetimeFigureOut">
              <a:rPr lang="en-US" smtClean="0"/>
              <a:t>1/26/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6568342-1743-6395-7757-C633CD773B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746E379-778E-6F53-95EF-4B9D8E41CB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88CAA4-0770-4949-AFC1-F1EECC2C14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60542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A217B3-F5FB-A0EC-D2CE-59AA968D944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6D39E6F-1C7F-277B-981A-22A180C9E0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9E1C34-B17B-674D-AD67-47CF507AABC5}" type="datetimeFigureOut">
              <a:rPr lang="en-US" smtClean="0"/>
              <a:t>1/26/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7FFFA85-F81B-E6AF-0ED5-8C7760F8FA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70101C7-BC95-A7B3-C209-FDC9AF60EC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88CAA4-0770-4949-AFC1-F1EECC2C14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9136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22EA6BF-0C93-AB7F-E392-3A414B5514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9E1C34-B17B-674D-AD67-47CF507AABC5}" type="datetimeFigureOut">
              <a:rPr lang="en-US" smtClean="0"/>
              <a:t>1/26/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F33E914-205F-E4FD-A39B-D6F15150F3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581C328-2449-0A5B-07A1-393605F1E3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88CAA4-0770-4949-AFC1-F1EECC2C14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07431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BC0FA9-D542-4A36-0A30-332B4F5E33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27F62CE-A136-F442-40BD-A4BB7A99EFE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F8A7B1B-4F2B-6E07-D8EA-149F9BB1ECF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02D64B4-2A26-FB45-596F-13699C4162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9E1C34-B17B-674D-AD67-47CF507AABC5}" type="datetimeFigureOut">
              <a:rPr lang="en-US" smtClean="0"/>
              <a:t>1/26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F37D104-7EBC-3F25-50BB-3300625FC7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6FA7870-D055-6CF8-5EE1-AFE69608DF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88CAA4-0770-4949-AFC1-F1EECC2C14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03181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DB4053B-69D6-A261-4EB7-305EA499FA6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0BF5847-4FA1-CC7F-3FDD-2359F47CFCD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1EE1718-0840-BB6B-543E-8F0348A1AA9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21F8241-5DA0-8142-FEBD-681B93ACC9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9E1C34-B17B-674D-AD67-47CF507AABC5}" type="datetimeFigureOut">
              <a:rPr lang="en-US" smtClean="0"/>
              <a:t>1/26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57E488D-973D-1ADC-43D0-B37DE70978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8A95417-1E3D-738F-8057-770079003D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88CAA4-0770-4949-AFC1-F1EECC2C14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41784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8790BAE-DDD8-1815-E588-C0D7C16D85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6D26D63-657B-B8BF-EDAE-336F8326CB8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08A50FC-10B5-BD87-7C6E-303B7554314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9E1C34-B17B-674D-AD67-47CF507AABC5}" type="datetimeFigureOut">
              <a:rPr lang="en-US" smtClean="0"/>
              <a:t>1/26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6E12D35-815F-5B75-A682-6A889F2B115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7EED1D5-642F-0C1A-D6FC-49910BDCBAA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88CAA4-0770-4949-AFC1-F1EECC2C14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51867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DF4A7D-6484-DC47-BA81-DA74F749593F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 err="1"/>
              <a:t>Gq</a:t>
            </a:r>
            <a:r>
              <a:rPr lang="en-US" dirty="0"/>
              <a:t> paper </a:t>
            </a:r>
            <a:r>
              <a:rPr lang="en-US" dirty="0" err="1"/>
              <a:t>Biorxiv</a:t>
            </a:r>
            <a:r>
              <a:rPr lang="en-US" dirty="0"/>
              <a:t> supplementary data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12F5C02-D552-3390-76B5-C681D80A7AC0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US" dirty="0"/>
              <a:t>1-26-24</a:t>
            </a:r>
          </a:p>
          <a:p>
            <a:r>
              <a:rPr lang="en-US" dirty="0"/>
              <a:t>Daniel Radin, Sheng Zhong, </a:t>
            </a:r>
            <a:r>
              <a:rPr lang="en-US" dirty="0" err="1"/>
              <a:t>Rok</a:t>
            </a:r>
            <a:r>
              <a:rPr lang="en-US" dirty="0"/>
              <a:t> </a:t>
            </a:r>
            <a:r>
              <a:rPr lang="en-US" dirty="0" err="1"/>
              <a:t>Cerne</a:t>
            </a:r>
            <a:r>
              <a:rPr lang="en-US" dirty="0"/>
              <a:t>, Jeffrey Witkin, Arnold </a:t>
            </a:r>
            <a:r>
              <a:rPr lang="en-US" dirty="0" err="1"/>
              <a:t>Lippa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8016907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6EC4F5-3DFF-BACF-1E29-1CD09734F8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Figure s1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E3955CC8-0824-6FC2-04B7-238ED799B11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19135" y="2404956"/>
            <a:ext cx="8353729" cy="34021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4018280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4DC707E-13D3-2907-7A7E-1F10F9289AA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Figure s2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E17D5E70-B082-E446-92E7-70AD6A0D592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81244" y="2686328"/>
            <a:ext cx="5484532" cy="244419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7368628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BF3008-BF23-EBE1-CC1D-C288AABDBFE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Figure s3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63CE95AD-4F53-C72C-16D7-EF2BEE6CB1A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46930" y="1690688"/>
            <a:ext cx="5943600" cy="46685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9134826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BD0CFF-5FB4-F4C2-6D60-CAE34AF0ECE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Figure s4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C66D35E4-06A9-7BC6-393E-5CEE40D3ED8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24412" y="1062355"/>
            <a:ext cx="5943600" cy="54305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022316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28</Words>
  <Application>Microsoft Macintosh PowerPoint</Application>
  <PresentationFormat>Widescreen</PresentationFormat>
  <Paragraphs>7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Gq paper Biorxiv supplementary data</vt:lpstr>
      <vt:lpstr>Figure s1</vt:lpstr>
      <vt:lpstr>Figure s2</vt:lpstr>
      <vt:lpstr>Figure s3</vt:lpstr>
      <vt:lpstr>Figure s4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Gq paper Biorxiv supplementary data</dc:title>
  <dc:creator>Radin, Daniel</dc:creator>
  <cp:lastModifiedBy>Radin, Daniel</cp:lastModifiedBy>
  <cp:revision>2</cp:revision>
  <dcterms:created xsi:type="dcterms:W3CDTF">2024-01-26T20:02:04Z</dcterms:created>
  <dcterms:modified xsi:type="dcterms:W3CDTF">2024-01-26T20:05:56Z</dcterms:modified>
</cp:coreProperties>
</file>